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96720" y="696960"/>
            <a:ext cx="26161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2642C5-75F2-455E-958E-AE8F45F41FE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2197080" y="696960"/>
            <a:ext cx="2616120" cy="348624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855CA1-F501-4995-8AF1-DEA16051787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DA5B4-B899-4777-BC30-4CA1DFBD7D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F13B7-B563-45BD-A3A8-CC55F0EDEA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F29DD2-C7E5-4FB3-BB47-B7B99DEFC0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15878-4471-4339-AF81-72E80F5199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E8048-2C79-4B9F-86A0-3176A00CD4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7DE82-F28D-4866-8F1B-94B2366492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AB57F-2284-4B7D-BE82-2E0DCEC649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6FA8F-143D-4A12-8F91-C749123B4F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04D8A-7F9B-44D3-90BB-A99B987031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35524-66E9-4EE3-B0EB-498CFE23AC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97716-FBEC-450E-A264-3A98575431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255A5-DBAA-40EB-B1CB-36B131D6D1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9E0D78-41E7-49A7-86D8-4F4F8673709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0"/>
          <p:cNvSpPr/>
          <p:nvPr/>
        </p:nvSpPr>
        <p:spPr>
          <a:xfrm>
            <a:off x="152280" y="152280"/>
            <a:ext cx="48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5"/>
          <p:cNvSpPr/>
          <p:nvPr/>
        </p:nvSpPr>
        <p:spPr>
          <a:xfrm rot="16200000">
            <a:off x="2403360" y="1935000"/>
            <a:ext cx="2724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rowth rat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#cells at 3dpt/ #cells at 1dpt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4674960" y="3513240"/>
            <a:ext cx="47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5568840" y="3513240"/>
            <a:ext cx="104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iBRCA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Chart 49" descr=""/>
          <p:cNvPicPr/>
          <p:nvPr/>
        </p:nvPicPr>
        <p:blipFill>
          <a:blip r:embed="rId1"/>
          <a:stretch/>
        </p:blipFill>
        <p:spPr>
          <a:xfrm>
            <a:off x="3956040" y="603360"/>
            <a:ext cx="2828880" cy="3066840"/>
          </a:xfrm>
          <a:prstGeom prst="rect">
            <a:avLst/>
          </a:prstGeom>
          <a:ln w="0">
            <a:noFill/>
          </a:ln>
        </p:spPr>
      </p:pic>
      <p:pic>
        <p:nvPicPr>
          <p:cNvPr id="53" name="Chart 51" descr=""/>
          <p:cNvPicPr/>
          <p:nvPr/>
        </p:nvPicPr>
        <p:blipFill>
          <a:blip r:embed="rId2"/>
          <a:stretch/>
        </p:blipFill>
        <p:spPr>
          <a:xfrm>
            <a:off x="536400" y="603360"/>
            <a:ext cx="2835360" cy="3060720"/>
          </a:xfrm>
          <a:prstGeom prst="rect">
            <a:avLst/>
          </a:prstGeom>
          <a:ln w="0">
            <a:noFill/>
          </a:ln>
        </p:spPr>
      </p:pic>
      <p:sp>
        <p:nvSpPr>
          <p:cNvPr id="54" name="Rectangle 45"/>
          <p:cNvSpPr/>
          <p:nvPr/>
        </p:nvSpPr>
        <p:spPr>
          <a:xfrm rot="16200000">
            <a:off x="-1006200" y="1939680"/>
            <a:ext cx="2724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rowth rat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#cells at 3dpt/ #cells at 1dpt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3"/>
          <p:cNvSpPr/>
          <p:nvPr/>
        </p:nvSpPr>
        <p:spPr>
          <a:xfrm>
            <a:off x="1265040" y="3519360"/>
            <a:ext cx="47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3"/>
          <p:cNvSpPr/>
          <p:nvPr/>
        </p:nvSpPr>
        <p:spPr>
          <a:xfrm>
            <a:off x="2238480" y="3519360"/>
            <a:ext cx="834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iE2F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0"/>
          <p:cNvSpPr/>
          <p:nvPr/>
        </p:nvSpPr>
        <p:spPr>
          <a:xfrm>
            <a:off x="3476520" y="152280"/>
            <a:ext cx="48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Chart 56" descr=""/>
          <p:cNvPicPr/>
          <p:nvPr/>
        </p:nvPicPr>
        <p:blipFill>
          <a:blip r:embed="rId3"/>
          <a:stretch/>
        </p:blipFill>
        <p:spPr>
          <a:xfrm>
            <a:off x="530280" y="5175360"/>
            <a:ext cx="2901960" cy="306072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45"/>
          <p:cNvSpPr/>
          <p:nvPr/>
        </p:nvSpPr>
        <p:spPr>
          <a:xfrm rot="16200000">
            <a:off x="-1025280" y="6511680"/>
            <a:ext cx="2724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rowth rat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#cells at 3dpt/ #cells at 1dpt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3"/>
          <p:cNvSpPr/>
          <p:nvPr/>
        </p:nvSpPr>
        <p:spPr>
          <a:xfrm>
            <a:off x="1245960" y="8091360"/>
            <a:ext cx="47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3"/>
          <p:cNvSpPr/>
          <p:nvPr/>
        </p:nvSpPr>
        <p:spPr>
          <a:xfrm>
            <a:off x="2219400" y="8091360"/>
            <a:ext cx="77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iSR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30"/>
          <p:cNvSpPr/>
          <p:nvPr/>
        </p:nvSpPr>
        <p:spPr>
          <a:xfrm>
            <a:off x="3476520" y="4572000"/>
            <a:ext cx="48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Chart 61" descr=""/>
          <p:cNvPicPr/>
          <p:nvPr/>
        </p:nvPicPr>
        <p:blipFill>
          <a:blip r:embed="rId4"/>
          <a:stretch/>
        </p:blipFill>
        <p:spPr>
          <a:xfrm>
            <a:off x="3938760" y="5175360"/>
            <a:ext cx="2906640" cy="3060720"/>
          </a:xfrm>
          <a:prstGeom prst="rect">
            <a:avLst/>
          </a:prstGeom>
          <a:ln w="0">
            <a:noFill/>
          </a:ln>
        </p:spPr>
      </p:pic>
      <p:sp>
        <p:nvSpPr>
          <p:cNvPr id="64" name="Rectangle 45"/>
          <p:cNvSpPr/>
          <p:nvPr/>
        </p:nvSpPr>
        <p:spPr>
          <a:xfrm rot="16200000">
            <a:off x="2427120" y="6511680"/>
            <a:ext cx="2724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rowth rat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#cells at 3dpt/ #cells at 1dpt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3"/>
          <p:cNvSpPr/>
          <p:nvPr/>
        </p:nvSpPr>
        <p:spPr>
          <a:xfrm>
            <a:off x="4698720" y="8091360"/>
            <a:ext cx="47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3"/>
          <p:cNvSpPr/>
          <p:nvPr/>
        </p:nvSpPr>
        <p:spPr>
          <a:xfrm>
            <a:off x="5680800" y="8091360"/>
            <a:ext cx="85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iAct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0"/>
          <p:cNvSpPr/>
          <p:nvPr/>
        </p:nvSpPr>
        <p:spPr>
          <a:xfrm>
            <a:off x="152280" y="4572000"/>
            <a:ext cx="48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4T04:15:08Z</dcterms:created>
  <dc:creator>Byung-Whi Kong</dc:creator>
  <dc:description/>
  <dc:language>en-US</dc:language>
  <cp:lastModifiedBy>bkongadmn</cp:lastModifiedBy>
  <dcterms:modified xsi:type="dcterms:W3CDTF">2011-11-14T11:34:34Z</dcterms:modified>
  <cp:revision>135</cp:revision>
  <dc:subject/>
  <dc:title>Slide 1</dc:title>
</cp:coreProperties>
</file>